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500563" cy="899953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2436DF-C612-4724-A48E-61C601D3B1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25360" y="360000"/>
            <a:ext cx="4051440" cy="15001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25360" y="2099880"/>
            <a:ext cx="4051440" cy="28332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25360" y="5202720"/>
            <a:ext cx="4051440" cy="28332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C949C6-28C8-48DC-9070-E3B2950D1C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25360" y="360000"/>
            <a:ext cx="4051440" cy="15001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25360" y="2099880"/>
            <a:ext cx="1976760" cy="28332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301480" y="2099880"/>
            <a:ext cx="1976760" cy="28332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25360" y="5202720"/>
            <a:ext cx="1976760" cy="28332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301480" y="5202720"/>
            <a:ext cx="1976760" cy="28332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1F0F2A-3439-4152-9343-FBBCDD02ED7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25360" y="360000"/>
            <a:ext cx="4051440" cy="15001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25360" y="2099880"/>
            <a:ext cx="1304280" cy="28332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595160" y="2099880"/>
            <a:ext cx="1304280" cy="28332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964960" y="2099880"/>
            <a:ext cx="1304280" cy="28332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25360" y="5202720"/>
            <a:ext cx="1304280" cy="28332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595160" y="5202720"/>
            <a:ext cx="1304280" cy="28332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964960" y="5202720"/>
            <a:ext cx="1304280" cy="28332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D26D06-BB63-4D17-AA4F-841C48A97D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25360" y="360000"/>
            <a:ext cx="4051440" cy="15001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25360" y="2099880"/>
            <a:ext cx="4051440" cy="594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44DF36-143C-4996-811D-B831462C8F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25360" y="360000"/>
            <a:ext cx="4051440" cy="15001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25360" y="2099880"/>
            <a:ext cx="4051440" cy="59403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C5202F-8249-4611-83C7-4F5B7AD315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25360" y="360000"/>
            <a:ext cx="4051440" cy="15001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25360" y="2099880"/>
            <a:ext cx="1976760" cy="59403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301480" y="2099880"/>
            <a:ext cx="1976760" cy="59403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BD8F7E-92CD-4891-A1D1-03380F6FAD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25360" y="360000"/>
            <a:ext cx="4051440" cy="15001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B8C1B4-84B7-4119-9C8A-A557ED189B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25360" y="360000"/>
            <a:ext cx="4051440" cy="6954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E6EA0A-A4AE-4AF3-A7C9-251E8C1E9B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25360" y="360000"/>
            <a:ext cx="4051440" cy="15001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25360" y="2099880"/>
            <a:ext cx="1976760" cy="28332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301480" y="2099880"/>
            <a:ext cx="1976760" cy="59403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25360" y="5202720"/>
            <a:ext cx="1976760" cy="28332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424AD1-5DDB-4827-8309-DDC0A1CE74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25360" y="360000"/>
            <a:ext cx="4051440" cy="15001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25360" y="2099880"/>
            <a:ext cx="1976760" cy="59403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301480" y="2099880"/>
            <a:ext cx="1976760" cy="28332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301480" y="5202720"/>
            <a:ext cx="1976760" cy="28332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A1B5EC-A07D-4353-9527-4C29EE4151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25360" y="360000"/>
            <a:ext cx="4051440" cy="15001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25360" y="2099880"/>
            <a:ext cx="1976760" cy="28332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301480" y="2099880"/>
            <a:ext cx="1976760" cy="28332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25360" y="5202720"/>
            <a:ext cx="4051440" cy="28332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277CFD-80F0-416B-B84F-B3C4128CC2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25360" y="360000"/>
            <a:ext cx="4051440" cy="15001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25360" y="2099880"/>
            <a:ext cx="4051440" cy="59403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 fontScale="96000"/>
          </a:bodyPr>
          <a:p>
            <a:pPr marL="283320" indent="-28332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13800" indent="-23580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944640" indent="-18900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322640" indent="-18900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699200" indent="-18756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699200" indent="-18756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699200" indent="-18756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25000" y="8197560"/>
            <a:ext cx="1050840" cy="62388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Autofit/>
          </a:bodyPr>
          <a:lstStyle>
            <a:lvl1pPr indent="0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538280" y="8197560"/>
            <a:ext cx="1425600" cy="62388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Autofit/>
          </a:bodyPr>
          <a:lstStyle>
            <a:lvl1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225600" y="8197560"/>
            <a:ext cx="1050840" cy="62388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Autofit/>
          </a:bodyPr>
          <a:lstStyle>
            <a:lvl1pPr indent="0" algn="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fld id="{9B407EF4-C662-4E44-9B5E-220983D7EF7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666720" y="324000"/>
            <a:ext cx="2814840" cy="2814480"/>
            <a:chOff x="666720" y="324000"/>
            <a:chExt cx="2814840" cy="281448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666720" y="324000"/>
              <a:ext cx="2814840" cy="28144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3" name=""/>
            <p:cNvGrpSpPr/>
            <p:nvPr/>
          </p:nvGrpSpPr>
          <p:grpSpPr>
            <a:xfrm>
              <a:off x="782640" y="436680"/>
              <a:ext cx="2664720" cy="2129400"/>
              <a:chOff x="782640" y="436680"/>
              <a:chExt cx="2664720" cy="2129400"/>
            </a:xfrm>
          </p:grpSpPr>
          <p:sp>
            <p:nvSpPr>
              <p:cNvPr id="44" name=""/>
              <p:cNvSpPr/>
              <p:nvPr/>
            </p:nvSpPr>
            <p:spPr>
              <a:xfrm>
                <a:off x="1593360" y="664560"/>
                <a:ext cx="6120" cy="159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1198440" y="1476720"/>
                <a:ext cx="232200" cy="166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</a:rPr>
                  <a:t>L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1470240" y="2261160"/>
                <a:ext cx="465480" cy="166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</a:rPr>
                  <a:t>ori ColE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1632960" y="2399400"/>
                <a:ext cx="441000" cy="166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</a:rPr>
                  <a:t>ori pVS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1992600" y="2334240"/>
                <a:ext cx="515520" cy="166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</a:rPr>
                  <a:t>repA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</a:rPr>
                  <a:t> pVS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2273040" y="2133360"/>
                <a:ext cx="500400" cy="166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</a:rPr>
                  <a:t>staA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</a:rPr>
                  <a:t> pVS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1210320" y="1794240"/>
                <a:ext cx="319320" cy="166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</a:rPr>
                  <a:t>nptII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2734560" y="1479960"/>
                <a:ext cx="238320" cy="166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</a:rPr>
                  <a:t>R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2610000" y="1339920"/>
                <a:ext cx="277920" cy="181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</a:rPr>
                  <a:t>T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Times New Roman"/>
                  </a:rPr>
                  <a:t>NOS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1406520" y="1107360"/>
                <a:ext cx="349200" cy="166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</a:rPr>
                  <a:t>hptI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1765800" y="919080"/>
                <a:ext cx="309960" cy="181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</a:rPr>
                  <a:t>P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Times New Roman"/>
                  </a:rPr>
                  <a:t>CaMV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1256040" y="1349640"/>
                <a:ext cx="314640" cy="181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</a:rPr>
                  <a:t>T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Times New Roman"/>
                  </a:rPr>
                  <a:t>CaMV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1726200" y="1549800"/>
                <a:ext cx="696960" cy="366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pCAMPMT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10.7 k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3074760" y="1105200"/>
                <a:ext cx="296280" cy="166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</a:rPr>
                  <a:t>Kpn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</a:rPr>
                  <a:t>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3103920" y="1254240"/>
                <a:ext cx="343440" cy="166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</a:rPr>
                  <a:t>Bst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</a:rPr>
                  <a:t>EI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2608560" y="607320"/>
                <a:ext cx="291600" cy="166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</a:rPr>
                  <a:t>Nco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</a:rPr>
                  <a:t>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3002400" y="1301040"/>
                <a:ext cx="127800" cy="27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 flipV="1">
                <a:off x="3003480" y="1206720"/>
                <a:ext cx="79200" cy="92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080" bIns="46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1053360" y="1261440"/>
                <a:ext cx="9288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 flipV="1">
                <a:off x="2607120" y="754920"/>
                <a:ext cx="65160" cy="101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 flipH="1" flipV="1">
                <a:off x="1482120" y="722880"/>
                <a:ext cx="116640" cy="98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1248480" y="577080"/>
                <a:ext cx="299520" cy="166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</a:rPr>
                  <a:t>Aat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</a:rPr>
                  <a:t>I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2134440" y="436680"/>
                <a:ext cx="374040" cy="166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</a:rPr>
                  <a:t>Bam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</a:rPr>
                  <a:t>H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782640" y="1145520"/>
                <a:ext cx="290160" cy="166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</a:rPr>
                  <a:t>Xho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</a:rPr>
                  <a:t>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1528920" y="513720"/>
                <a:ext cx="290160" cy="166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</a:rPr>
                  <a:t>Xho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</a:rPr>
                  <a:t>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 flipV="1">
                <a:off x="2185560" y="591120"/>
                <a:ext cx="14760" cy="121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2433960" y="1182240"/>
                <a:ext cx="354240" cy="166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</a:rPr>
                  <a:t>‘</a:t>
                </a: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</a:rPr>
                  <a:t>pmt1’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2186640" y="920880"/>
                <a:ext cx="309960" cy="181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9400" rIns="59400" tIns="29880" bIns="2988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</a:rPr>
                  <a:t>P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Times New Roman"/>
                  </a:rPr>
                  <a:t>CaMV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pic>
        <p:nvPicPr>
          <p:cNvPr id="72" name="" descr=""/>
          <p:cNvPicPr/>
          <p:nvPr/>
        </p:nvPicPr>
        <p:blipFill>
          <a:blip r:embed="rId2"/>
          <a:stretch/>
        </p:blipFill>
        <p:spPr>
          <a:xfrm>
            <a:off x="701640" y="2916360"/>
            <a:ext cx="2844720" cy="2842920"/>
          </a:xfrm>
          <a:prstGeom prst="rect">
            <a:avLst/>
          </a:prstGeom>
          <a:ln w="0">
            <a:noFill/>
          </a:ln>
        </p:spPr>
      </p:pic>
      <p:grpSp>
        <p:nvGrpSpPr>
          <p:cNvPr id="73" name=""/>
          <p:cNvGrpSpPr/>
          <p:nvPr/>
        </p:nvGrpSpPr>
        <p:grpSpPr>
          <a:xfrm>
            <a:off x="842400" y="3084480"/>
            <a:ext cx="2439720" cy="2092320"/>
            <a:chOff x="842400" y="3084480"/>
            <a:chExt cx="2439720" cy="2092320"/>
          </a:xfrm>
        </p:grpSpPr>
        <p:sp>
          <p:nvSpPr>
            <p:cNvPr id="74" name=""/>
            <p:cNvSpPr/>
            <p:nvPr/>
          </p:nvSpPr>
          <p:spPr>
            <a:xfrm>
              <a:off x="1333440" y="3989160"/>
              <a:ext cx="23220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L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1514160" y="4836960"/>
              <a:ext cx="46548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ri ColE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667880" y="5010120"/>
              <a:ext cx="44100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ri pVS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023560" y="4968720"/>
              <a:ext cx="51552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repA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pVS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381760" y="4624200"/>
              <a:ext cx="50040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staA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pVS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1261080" y="4338360"/>
              <a:ext cx="31932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nptII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712240" y="3920760"/>
              <a:ext cx="23832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R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588040" y="3771720"/>
              <a:ext cx="277920" cy="181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O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421000" y="3671640"/>
              <a:ext cx="29628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sat-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238480" y="3508200"/>
              <a:ext cx="444240" cy="181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P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O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1789200" y="3531960"/>
              <a:ext cx="334800" cy="181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P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CaMV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409760" y="3846240"/>
              <a:ext cx="339840" cy="181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CaMV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1788480" y="4149360"/>
              <a:ext cx="669600" cy="36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 algn="ctr"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pNATPMT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9.7 k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985840" y="3520800"/>
              <a:ext cx="29628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Kpn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505160" y="3097080"/>
              <a:ext cx="29160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Nco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flipV="1">
              <a:off x="2922480" y="3633120"/>
              <a:ext cx="74880" cy="58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flipV="1">
              <a:off x="2411280" y="3263400"/>
              <a:ext cx="28800" cy="90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flipH="1" flipV="1">
              <a:off x="1736280" y="3283920"/>
              <a:ext cx="41400" cy="87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flipH="1" flipV="1">
              <a:off x="1185840" y="3712680"/>
              <a:ext cx="84240" cy="57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842400" y="3595320"/>
              <a:ext cx="34344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Bst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EI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2381760" y="3084480"/>
              <a:ext cx="38916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Sau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3A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1523880" y="3668400"/>
              <a:ext cx="35424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‘</a:t>
              </a: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pmt1’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6" name=""/>
          <p:cNvGrpSpPr/>
          <p:nvPr/>
        </p:nvGrpSpPr>
        <p:grpSpPr>
          <a:xfrm>
            <a:off x="624960" y="5754600"/>
            <a:ext cx="3028680" cy="2814840"/>
            <a:chOff x="624960" y="5754600"/>
            <a:chExt cx="3028680" cy="2814840"/>
          </a:xfrm>
        </p:grpSpPr>
        <p:pic>
          <p:nvPicPr>
            <p:cNvPr id="97" name="" descr=""/>
            <p:cNvPicPr/>
            <p:nvPr/>
          </p:nvPicPr>
          <p:blipFill>
            <a:blip r:embed="rId3"/>
            <a:stretch/>
          </p:blipFill>
          <p:spPr>
            <a:xfrm>
              <a:off x="753120" y="5754600"/>
              <a:ext cx="2814480" cy="2814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8" name=""/>
            <p:cNvSpPr/>
            <p:nvPr/>
          </p:nvSpPr>
          <p:spPr>
            <a:xfrm flipV="1">
              <a:off x="1054800" y="7351200"/>
              <a:ext cx="100800" cy="1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240" bIns="-30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2905920" y="7861320"/>
              <a:ext cx="78480" cy="71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 flipV="1">
              <a:off x="1079280" y="7435080"/>
              <a:ext cx="96840" cy="21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790720" y="7270200"/>
              <a:ext cx="23220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L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1301400" y="7162200"/>
              <a:ext cx="46548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ri ColE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1401120" y="7518960"/>
              <a:ext cx="44100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ri pVS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1545840" y="7667280"/>
              <a:ext cx="51552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repA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pVS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1888920" y="7827840"/>
              <a:ext cx="50040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staA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pVS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2616480" y="7483320"/>
              <a:ext cx="31932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nptII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1305000" y="7286040"/>
              <a:ext cx="23832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R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2756160" y="7128000"/>
              <a:ext cx="277920" cy="181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O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2726280" y="6870960"/>
              <a:ext cx="33660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hptI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2640240" y="6629400"/>
              <a:ext cx="273240" cy="181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P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O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2461320" y="6508800"/>
              <a:ext cx="309960" cy="181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P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CaMV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1517400" y="6513480"/>
              <a:ext cx="314640" cy="181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CaMV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1796760" y="6980400"/>
              <a:ext cx="726120" cy="36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 algn="ctr"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pRESC5PM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12.4 k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3291840" y="7106040"/>
              <a:ext cx="29628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Kpn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3144600" y="6476760"/>
              <a:ext cx="32508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Bst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Y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1160640" y="6094080"/>
              <a:ext cx="29160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Nco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 flipH="1" flipV="1">
              <a:off x="3185280" y="7192800"/>
              <a:ext cx="109440" cy="3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3159000" y="7383960"/>
              <a:ext cx="112680" cy="26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 flipH="1">
              <a:off x="2940840" y="6435000"/>
              <a:ext cx="80640" cy="6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 flipV="1">
              <a:off x="3044520" y="6593040"/>
              <a:ext cx="99360" cy="53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480" bIns="6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 flipV="1">
              <a:off x="2277000" y="6059160"/>
              <a:ext cx="12600" cy="85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 flipH="1" flipV="1">
              <a:off x="1894680" y="6070320"/>
              <a:ext cx="28440" cy="92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080" bIns="460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 flipV="1">
              <a:off x="2775600" y="6266520"/>
              <a:ext cx="60480" cy="77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240" bIns="30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1297080" y="6350040"/>
              <a:ext cx="15552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1389240" y="6272280"/>
              <a:ext cx="60120" cy="152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 flipH="1" flipV="1">
              <a:off x="1297080" y="6438960"/>
              <a:ext cx="80640" cy="62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840" bIns="15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1008720" y="6369840"/>
              <a:ext cx="29952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Aat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961920" y="6234840"/>
              <a:ext cx="34344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Bst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EI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3018240" y="6322320"/>
              <a:ext cx="29016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Xba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3279600" y="7222680"/>
              <a:ext cx="37404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Bam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H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2839680" y="6157080"/>
              <a:ext cx="29016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Xho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1683000" y="5917320"/>
              <a:ext cx="26100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Pst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656640" y="7283880"/>
              <a:ext cx="38304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Hin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dII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624960" y="7387200"/>
              <a:ext cx="43812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Bst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1107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2990520" y="7865280"/>
              <a:ext cx="28080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Sph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3270600" y="7339320"/>
              <a:ext cx="34524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Eco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R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1367640" y="6718320"/>
              <a:ext cx="23220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bl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2230200" y="5907600"/>
              <a:ext cx="27648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Sac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flipH="1" flipV="1">
              <a:off x="2016360" y="6049800"/>
              <a:ext cx="15840" cy="95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1954440" y="5895720"/>
              <a:ext cx="29952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Bgl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flipH="1" flipV="1">
              <a:off x="3176640" y="7293240"/>
              <a:ext cx="118080" cy="7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1991160" y="6293520"/>
              <a:ext cx="33912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pdk i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2233440" y="6359400"/>
              <a:ext cx="35424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‘</a:t>
              </a: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pmt1’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1618200" y="6404760"/>
              <a:ext cx="354240" cy="1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9400" rIns="59400" tIns="29880" bIns="298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‘</a:t>
              </a:r>
              <a:r>
                <a:rPr b="0" i="1" lang="en-US" sz="700" spc="-1" strike="noStrike">
                  <a:solidFill>
                    <a:srgbClr val="000000"/>
                  </a:solidFill>
                  <a:latin typeface="Times New Roman"/>
                </a:rPr>
                <a:t>pmt1’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5" name=""/>
          <p:cNvSpPr/>
          <p:nvPr/>
        </p:nvSpPr>
        <p:spPr>
          <a:xfrm>
            <a:off x="522360" y="2440080"/>
            <a:ext cx="293400" cy="38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1" lang="de-DE" sz="2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515880" y="5056200"/>
            <a:ext cx="293400" cy="38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1" lang="de-DE" sz="2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522360" y="7885080"/>
            <a:ext cx="293400" cy="38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1" lang="de-DE" sz="2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3-12-21T07:52:58Z</dcterms:created>
  <dc:creator>Anke Steppuhn</dc:creator>
  <dc:description/>
  <dc:language>en-US</dc:language>
  <cp:lastModifiedBy>Anke Steppuhn</cp:lastModifiedBy>
  <dcterms:modified xsi:type="dcterms:W3CDTF">2004-06-13T19:15:11Z</dcterms:modified>
  <cp:revision>5</cp:revision>
  <dc:subject/>
  <dc:title>Slide 1</dc:title>
</cp:coreProperties>
</file>